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02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63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874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67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643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79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079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751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405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010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055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363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21BCE-594E-4A89-9C6C-B38BCEC1094D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3B6650-083C-4A5E-8699-A4603ADC51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837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65AE1E17-9518-4FD7-A137-7B95A23F4C9E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saturation sat="40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022105" y="1021745"/>
            <a:ext cx="4147791" cy="269169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D1B35DB-22BD-476E-A5D7-224CFF1B81DC}"/>
              </a:ext>
            </a:extLst>
          </p:cNvPr>
          <p:cNvSpPr txBox="1"/>
          <p:nvPr/>
        </p:nvSpPr>
        <p:spPr>
          <a:xfrm>
            <a:off x="4319263" y="2263862"/>
            <a:ext cx="45717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FPR2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BC4C40F-2CA9-4CB2-8C14-2BFB6D871C81}"/>
              </a:ext>
            </a:extLst>
          </p:cNvPr>
          <p:cNvSpPr txBox="1"/>
          <p:nvPr/>
        </p:nvSpPr>
        <p:spPr>
          <a:xfrm>
            <a:off x="5313865" y="2236123"/>
            <a:ext cx="52770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52DD46B-40ED-4B80-8A51-77413756AFF2}"/>
              </a:ext>
            </a:extLst>
          </p:cNvPr>
          <p:cNvSpPr txBox="1"/>
          <p:nvPr/>
        </p:nvSpPr>
        <p:spPr>
          <a:xfrm>
            <a:off x="4407284" y="1712295"/>
            <a:ext cx="46358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dirty="0">
                <a:solidFill>
                  <a:schemeClr val="accent3">
                    <a:lumMod val="75000"/>
                  </a:schemeClr>
                </a:solidFill>
              </a:rPr>
              <a:t>TRPA1</a:t>
            </a:r>
            <a:endParaRPr lang="zh-CN" altLang="en-US" sz="83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8B41BB5-41C4-4553-9C8F-4C4A0D1D2131}"/>
              </a:ext>
            </a:extLst>
          </p:cNvPr>
          <p:cNvSpPr txBox="1"/>
          <p:nvPr/>
        </p:nvSpPr>
        <p:spPr>
          <a:xfrm>
            <a:off x="5122563" y="1646848"/>
            <a:ext cx="49404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dirty="0">
                <a:solidFill>
                  <a:schemeClr val="accent3">
                    <a:lumMod val="75000"/>
                  </a:schemeClr>
                </a:solidFill>
              </a:rPr>
              <a:t>TRPM8</a:t>
            </a:r>
            <a:endParaRPr lang="zh-CN" altLang="en-US" sz="83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9CAEF2B-A625-4D07-9DB6-490DA5007AE5}"/>
              </a:ext>
            </a:extLst>
          </p:cNvPr>
          <p:cNvSpPr txBox="1"/>
          <p:nvPr/>
        </p:nvSpPr>
        <p:spPr>
          <a:xfrm>
            <a:off x="7730283" y="1806240"/>
            <a:ext cx="52770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TRPV1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3B83931-8BCB-4D50-AF3F-A39D74EF5A57}"/>
              </a:ext>
            </a:extLst>
          </p:cNvPr>
          <p:cNvSpPr txBox="1"/>
          <p:nvPr/>
        </p:nvSpPr>
        <p:spPr>
          <a:xfrm>
            <a:off x="6592839" y="1744663"/>
            <a:ext cx="46358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dirty="0">
                <a:solidFill>
                  <a:schemeClr val="accent3">
                    <a:lumMod val="75000"/>
                  </a:schemeClr>
                </a:solidFill>
              </a:rPr>
              <a:t>TRPA1</a:t>
            </a:r>
            <a:endParaRPr lang="zh-CN" altLang="en-US" sz="83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684EEB5-B1E1-4390-BB0F-A3AA63BF8D8C}"/>
              </a:ext>
            </a:extLst>
          </p:cNvPr>
          <p:cNvSpPr txBox="1"/>
          <p:nvPr/>
        </p:nvSpPr>
        <p:spPr>
          <a:xfrm>
            <a:off x="7216077" y="1661543"/>
            <a:ext cx="49404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dirty="0">
                <a:solidFill>
                  <a:schemeClr val="accent3">
                    <a:lumMod val="75000"/>
                  </a:schemeClr>
                </a:solidFill>
              </a:rPr>
              <a:t>TRPM8</a:t>
            </a:r>
            <a:endParaRPr lang="zh-CN" altLang="en-US" sz="831" dirty="0">
              <a:solidFill>
                <a:schemeClr val="accent3">
                  <a:lumMod val="75000"/>
                </a:schemeClr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45C1042-BCAB-4DD6-B986-77DA8329937D}"/>
              </a:ext>
            </a:extLst>
          </p:cNvPr>
          <p:cNvSpPr txBox="1"/>
          <p:nvPr/>
        </p:nvSpPr>
        <p:spPr>
          <a:xfrm>
            <a:off x="6050394" y="2263862"/>
            <a:ext cx="45717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FPR2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33B4855-9005-4D3B-84B5-5AEFE415D31E}"/>
              </a:ext>
            </a:extLst>
          </p:cNvPr>
          <p:cNvSpPr txBox="1"/>
          <p:nvPr/>
        </p:nvSpPr>
        <p:spPr>
          <a:xfrm>
            <a:off x="6128120" y="1769059"/>
            <a:ext cx="53412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Ac2-26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22585BD-A7DA-40E5-8A36-6E57D18B3635}"/>
              </a:ext>
            </a:extLst>
          </p:cNvPr>
          <p:cNvSpPr txBox="1"/>
          <p:nvPr/>
        </p:nvSpPr>
        <p:spPr>
          <a:xfrm>
            <a:off x="6714360" y="2493752"/>
            <a:ext cx="463588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PLCβ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2E2C47E-CDB1-4D5B-B0F1-6B7D70875620}"/>
              </a:ext>
            </a:extLst>
          </p:cNvPr>
          <p:cNvSpPr txBox="1"/>
          <p:nvPr/>
        </p:nvSpPr>
        <p:spPr>
          <a:xfrm>
            <a:off x="6922900" y="2110016"/>
            <a:ext cx="402674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US" altLang="zh-CN" sz="831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zh-CN" altLang="en-US" sz="831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62771BE-7A66-43AA-B59B-FB40DB97E869}"/>
              </a:ext>
            </a:extLst>
          </p:cNvPr>
          <p:cNvSpPr txBox="1"/>
          <p:nvPr/>
        </p:nvSpPr>
        <p:spPr>
          <a:xfrm>
            <a:off x="7435368" y="2161327"/>
            <a:ext cx="40908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31" b="1" dirty="0" err="1">
                <a:latin typeface="Arial" panose="020B0604020202020204" pitchFamily="34" charset="0"/>
                <a:cs typeface="Arial" panose="020B0604020202020204" pitchFamily="34" charset="0"/>
              </a:rPr>
              <a:t>CaM</a:t>
            </a:r>
            <a:endParaRPr lang="zh-CN" altLang="en-US" sz="83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4115226" y="4436356"/>
            <a:ext cx="4025788" cy="987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31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le 5. Summary graph.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(Left) Genetic deletion of 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 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83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xA1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/-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increases capsaicin mediated Ca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sponse and TRPV1 current in DRG neurons, and selectively enhances noxious heat or capsaicin induced pain sensation. (Right) ANXA1 mimic peptide Ac2-26 binds with FPR2, activates FPR2 coupled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i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/o signaling pathway, increases intracellular Ca</a:t>
            </a:r>
            <a:r>
              <a:rPr lang="en-US" altLang="zh-CN" sz="831" kern="1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+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hich binds to 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lmodulin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83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M</a:t>
            </a:r>
            <a:r>
              <a:rPr lang="en-US" altLang="zh-CN" sz="83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and enhances  CaM-TRPV1 interaction, thus desensitizes TRPV1, finally decreases the nociceptive transmission and exerts analgesic effects.</a:t>
            </a:r>
            <a:endParaRPr lang="zh-CN" altLang="zh-CN" sz="831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4787856" y="3650253"/>
            <a:ext cx="628698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69" i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xA1</a:t>
            </a:r>
            <a:r>
              <a:rPr lang="en-US" altLang="zh-CN" sz="969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endParaRPr lang="zh-CN" altLang="en-US" sz="969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713706" y="3664282"/>
            <a:ext cx="628698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69" i="1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nxA1</a:t>
            </a:r>
            <a:r>
              <a:rPr lang="en-US" altLang="zh-CN" sz="969" kern="100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/-</a:t>
            </a:r>
            <a:endParaRPr lang="zh-CN" altLang="en-US" sz="969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7219305" y="3664282"/>
            <a:ext cx="679545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69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+ Ac2-26</a:t>
            </a:r>
            <a:endParaRPr lang="zh-CN" altLang="en-US" sz="969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9">
            <a:extLst>
              <a:ext uri="{FF2B5EF4-FFF2-40B4-BE49-F238E27FC236}">
                <a16:creationId xmlns:a16="http://schemas.microsoft.com/office/drawing/2014/main" id="{1CF9F106-518D-4128-9C96-C908ED048F23}"/>
              </a:ext>
            </a:extLst>
          </p:cNvPr>
          <p:cNvSpPr txBox="1"/>
          <p:nvPr/>
        </p:nvSpPr>
        <p:spPr>
          <a:xfrm>
            <a:off x="3824458" y="176460"/>
            <a:ext cx="128592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</a:t>
            </a:r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5" name="矩形 4"/>
          <p:cNvSpPr/>
          <p:nvPr/>
        </p:nvSpPr>
        <p:spPr>
          <a:xfrm>
            <a:off x="3853714" y="486857"/>
            <a:ext cx="1088760" cy="2414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69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mmary graph</a:t>
            </a:r>
            <a:r>
              <a:rPr lang="en-US" altLang="zh-CN" sz="969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sz="969" dirty="0"/>
          </a:p>
        </p:txBody>
      </p:sp>
    </p:spTree>
    <p:extLst>
      <p:ext uri="{BB962C8B-B14F-4D97-AF65-F5344CB8AC3E}">
        <p14:creationId xmlns:p14="http://schemas.microsoft.com/office/powerpoint/2010/main" val="4012065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5</Words>
  <Application>Microsoft Office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undarya NR.</dc:creator>
  <cp:lastModifiedBy>peilei</cp:lastModifiedBy>
  <cp:revision>2</cp:revision>
  <dcterms:created xsi:type="dcterms:W3CDTF">2021-08-17T15:12:21Z</dcterms:created>
  <dcterms:modified xsi:type="dcterms:W3CDTF">2021-08-20T05:39:53Z</dcterms:modified>
</cp:coreProperties>
</file>